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883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B91D79B-8300-F5E5-880C-EA38D96C90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758B26FF-77EB-C27E-A3A4-1771849113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F35720-A080-FB66-154A-41357223F6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9759D-313A-4767-94E3-29A2A717691B}" type="datetimeFigureOut">
              <a:rPr lang="zh-CN" altLang="en-US" smtClean="0"/>
              <a:t>2024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EC2554-E25C-14AC-3BB2-9B6D4EEEE8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5837F54-8A58-3019-C30D-04CAA6A319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F09B2-FC8F-4300-A119-D8337157EF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62124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07B5644-8F4A-7C06-75B3-DF50585884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017F22C-2F26-FBD6-0EBB-7D9E14BF09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03A05D3-D366-0F07-2C66-88AB560C3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9759D-313A-4767-94E3-29A2A717691B}" type="datetimeFigureOut">
              <a:rPr lang="zh-CN" altLang="en-US" smtClean="0"/>
              <a:t>2024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E60979-0DEF-923B-BDF2-D176BBF776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52C4CCF-01A2-E3BE-3748-D6BD3869A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F09B2-FC8F-4300-A119-D8337157EF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5494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021533D-8BD7-D9B8-F2EC-C36F4BCC93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2188672-01D1-D022-5C9B-B6CC00009D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2ABCB4-1714-12BC-F85A-3705065C8B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9759D-313A-4767-94E3-29A2A717691B}" type="datetimeFigureOut">
              <a:rPr lang="zh-CN" altLang="en-US" smtClean="0"/>
              <a:t>2024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1BAEB13-98C7-84F2-5DFA-EFA41AD18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0881A4-EF8F-84DF-8A19-488A781BB9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F09B2-FC8F-4300-A119-D8337157EF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252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467892-7F83-158E-0EC5-7AD4834697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289612E-FD1F-D1E7-2AE8-F80FB5F8D2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FA03BA6-6CB4-C930-1FFF-87A95472F7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9759D-313A-4767-94E3-29A2A717691B}" type="datetimeFigureOut">
              <a:rPr lang="zh-CN" altLang="en-US" smtClean="0"/>
              <a:t>2024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3DC64F-DA22-58BC-88BB-A5C0C0D532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C38718C-F4BB-C702-CCF9-E4FB92B67D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F09B2-FC8F-4300-A119-D8337157EF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9585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29080E-A9B1-DC0D-63BA-8DA14D0579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E722705-CDAD-D2DF-B353-804C2A7083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54503E5-CD03-3D1D-0870-EA2844FB10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9759D-313A-4767-94E3-29A2A717691B}" type="datetimeFigureOut">
              <a:rPr lang="zh-CN" altLang="en-US" smtClean="0"/>
              <a:t>2024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D89C5C7-C7C9-9003-C4D4-651984C483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DB7D5F5-0825-E67F-FE14-A9BD7D695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F09B2-FC8F-4300-A119-D8337157EF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778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B08B19-944A-382F-2251-70294A2452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4185E3B-1C65-C53C-9961-21F262099E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8E02167-A47F-ECBC-F45C-689138404E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8E83B96-B38E-43AF-17B1-4891856E62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9759D-313A-4767-94E3-29A2A717691B}" type="datetimeFigureOut">
              <a:rPr lang="zh-CN" altLang="en-US" smtClean="0"/>
              <a:t>2024/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F5CFB91-2671-B91D-D024-D4DB567E2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8414F92-72A2-1D2D-9513-C10BB8072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F09B2-FC8F-4300-A119-D8337157EF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9303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FA15DF9-10FC-FDBA-CC7B-7FA5E05B19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66029E6-5B34-3A8C-DF58-7B5513A352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E9B0017-5365-AD22-4260-56735E77EF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A731795-EA8C-AA9B-22D1-F223EA2CE4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5DC0154-3807-91AC-B003-AB11F6BA34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F12C65D-444D-C67D-3DF8-C6EB647B2D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9759D-313A-4767-94E3-29A2A717691B}" type="datetimeFigureOut">
              <a:rPr lang="zh-CN" altLang="en-US" smtClean="0"/>
              <a:t>2024/2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A56A4F3-3278-E47F-ABFC-28B293CF9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E86FEED-8AEC-251D-CDB3-6BBA0EF47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F09B2-FC8F-4300-A119-D8337157EF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9906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7A23A5-1364-5A04-87AD-709B1B6331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74761D-6E49-F886-FFA0-1B1B30BA14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9759D-313A-4767-94E3-29A2A717691B}" type="datetimeFigureOut">
              <a:rPr lang="zh-CN" altLang="en-US" smtClean="0"/>
              <a:t>2024/2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E4D5473-1915-6152-DB48-358A760B2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1ED1E37-1A02-6E61-B28C-3DBB7A324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F09B2-FC8F-4300-A119-D8337157EF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6589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DDE97DF-CD1E-39EF-BE49-4026375CAA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9759D-313A-4767-94E3-29A2A717691B}" type="datetimeFigureOut">
              <a:rPr lang="zh-CN" altLang="en-US" smtClean="0"/>
              <a:t>2024/2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762DEF0-7281-0F32-39B0-C0D0318614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D656A19-9AAC-6092-10CB-001062E63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F09B2-FC8F-4300-A119-D8337157EF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4996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0EB155-6F1D-C245-D5E9-9E6AEF7D3E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B16AEC8-00D4-11B5-28F4-DE4186FF60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5B67543-9874-F003-8342-981284B67C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1569DBD-7251-464F-928F-C60050652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9759D-313A-4767-94E3-29A2A717691B}" type="datetimeFigureOut">
              <a:rPr lang="zh-CN" altLang="en-US" smtClean="0"/>
              <a:t>2024/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56DE052-4A19-9C26-0388-511C5CD61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A002078-98A1-8571-727D-C878E39DA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F09B2-FC8F-4300-A119-D8337157EF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764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BA4C4E-61A0-3082-5797-6AEAA76A3D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5C1D9DB-7476-D9FB-D9A7-8F1DF1EA53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7046F3F-28B1-8680-8C54-685BFA2E6A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8E65F83-796C-7FBA-256C-3B4A47FB7B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9759D-313A-4767-94E3-29A2A717691B}" type="datetimeFigureOut">
              <a:rPr lang="zh-CN" altLang="en-US" smtClean="0"/>
              <a:t>2024/2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06FF282-482C-B122-F115-419FB2125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E17B7DF-96D3-BBA3-DF04-B15500F3D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BF09B2-FC8F-4300-A119-D8337157EF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6043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2800932-7A65-4061-11D0-D18832D5FF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A7C5E28-8511-6EAD-18EC-548C40D5F5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3394EF-ADD7-DE43-10AA-3EBDA3CAB5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E9759D-313A-4767-94E3-29A2A717691B}" type="datetimeFigureOut">
              <a:rPr lang="zh-CN" altLang="en-US" smtClean="0"/>
              <a:t>2024/2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240743-1836-A32A-A55C-CC9F8926A0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B829B04-07F1-AFBC-BC23-023EB0555B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BF09B2-FC8F-4300-A119-D8337157EF5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83304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EB9E93CA-0145-E9BA-5488-2C23210FEE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4991"/>
            <a:ext cx="12192000" cy="6150457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64DDB0AA-78E8-6983-83A2-5FDE27618FFF}"/>
              </a:ext>
            </a:extLst>
          </p:cNvPr>
          <p:cNvSpPr txBox="1"/>
          <p:nvPr/>
        </p:nvSpPr>
        <p:spPr>
          <a:xfrm>
            <a:off x="2504661" y="6380922"/>
            <a:ext cx="7653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alignment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tu.DM.01G002140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42076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A3CF702-6454-CEFD-7CEB-35AC6C074ED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30826810-24F6-AB63-10C8-980F6A87CD5B}"/>
              </a:ext>
            </a:extLst>
          </p:cNvPr>
          <p:cNvSpPr txBox="1"/>
          <p:nvPr/>
        </p:nvSpPr>
        <p:spPr>
          <a:xfrm>
            <a:off x="2504661" y="6380922"/>
            <a:ext cx="7653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alignment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tu.DM.03G037120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EF01466-235C-0006-FD00-2829E8DD3B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9183"/>
            <a:ext cx="12192000" cy="6560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3306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8887F1C-3629-D076-3F16-154B4A7B3AA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850F5E06-1EF6-0123-0F10-4EA8523A6382}"/>
              </a:ext>
            </a:extLst>
          </p:cNvPr>
          <p:cNvSpPr txBox="1"/>
          <p:nvPr/>
        </p:nvSpPr>
        <p:spPr>
          <a:xfrm>
            <a:off x="2504661" y="6380922"/>
            <a:ext cx="7653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alignment of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ltu.DM.01G038840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D037464-54D7-FFC8-9DA4-0B9F84F98F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4747"/>
            <a:ext cx="12192000" cy="61504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7008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3</Words>
  <Application>Microsoft Office PowerPoint</Application>
  <PresentationFormat>宽屏</PresentationFormat>
  <Paragraphs>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天依 洛</dc:creator>
  <cp:lastModifiedBy>天依 洛</cp:lastModifiedBy>
  <cp:revision>1</cp:revision>
  <dcterms:created xsi:type="dcterms:W3CDTF">2024-02-19T08:39:11Z</dcterms:created>
  <dcterms:modified xsi:type="dcterms:W3CDTF">2024-02-19T08:51:16Z</dcterms:modified>
</cp:coreProperties>
</file>